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8D2DD-8D9E-4A18-8511-88C307183C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A19BB8-88A2-4E76-8D69-A3EFE69928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400D2-8818-487B-866B-05A3FD4355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27B8C-8CE6-4A79-AE99-E61BD4EA05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B082B-1D70-4CBD-99F4-7FB7B2199E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C8082-F043-4F1B-8F5C-8CD6585DDF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C4BD9-F73C-4760-9BA1-AB396EA05E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EBE15-0A6C-49D5-A36B-E964C67703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DAFE9-6801-498F-8A1B-E9956F9AAB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5BBEB-29CC-40C0-9177-5E50EF92F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0224F-4AE8-4BA0-8F04-4D76F9CC5F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57BCD-15DF-4ABE-BAD8-28068DFA0E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F43EA0-6ECC-47AE-AC20-B9AF985150F3}" type="slidenum">
              <a:rPr b="0" lang="ko-KR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539"/>
          <p:cNvSpPr/>
          <p:nvPr/>
        </p:nvSpPr>
        <p:spPr>
          <a:xfrm>
            <a:off x="104760" y="0"/>
            <a:ext cx="276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10a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95280" y="1628640"/>
          <a:ext cx="8280360" cy="3803760"/>
        </p:xfrm>
        <a:graphic>
          <a:graphicData uri="http://schemas.openxmlformats.org/drawingml/2006/table">
            <a:tbl>
              <a:tblPr/>
              <a:tblGrid>
                <a:gridCol w="2592360"/>
                <a:gridCol w="442800"/>
                <a:gridCol w="247680"/>
                <a:gridCol w="285840"/>
                <a:gridCol w="285840"/>
                <a:gridCol w="285840"/>
                <a:gridCol w="247320"/>
                <a:gridCol w="285840"/>
                <a:gridCol w="285840"/>
                <a:gridCol w="285840"/>
                <a:gridCol w="249120"/>
                <a:gridCol w="284040"/>
                <a:gridCol w="285840"/>
                <a:gridCol w="285840"/>
                <a:gridCol w="249120"/>
                <a:gridCol w="284400"/>
                <a:gridCol w="285480"/>
                <a:gridCol w="285840"/>
                <a:gridCol w="249120"/>
                <a:gridCol w="576360"/>
              </a:tblGrid>
              <a:tr h="269640"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ymb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/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cession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oll-like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l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5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8.7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1905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oll-like receptor 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lr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129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oll-like receptor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lr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92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oll-like receptor 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lr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160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Myeloid differentiation primary response gene 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Myd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4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85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ANK-binding kinas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bk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9786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uclear factor of kappa light chain gene enhancer in B-cells 1, p1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fk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68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uclear factor of kappa light polypeptide gene enhancer in B-cells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fkb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940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nf receptor-associated factor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ra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1632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nf receptor-associated factor 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raf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942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ripartite motif protein 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rim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XM_126545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RAF family member-associated Nf-kappa B activa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an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152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ignal transducer and activator of transcriptio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ta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6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9283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ignal transducer and activator of transcription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ta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9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6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8.7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6</a:t>
                      </a: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996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15 ubiquitin-like modifi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15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4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1.9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578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Janus kinase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Ja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41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(alpha and beta)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a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0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uppressor of cytokine signaling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oc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9896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COMM domain containing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Commd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4451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Cylindromatosis (turban tumor syndrom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Cyl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7336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leukin-1 receptor-associated kinase 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ak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9926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yrosine kinase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y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879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yrosine kinase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yk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879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DZ and LIM domain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dli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9</a:t>
                      </a: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4597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ctivating transcription fac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t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971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 Box 9502"/>
          <p:cNvSpPr/>
          <p:nvPr/>
        </p:nvSpPr>
        <p:spPr>
          <a:xfrm>
            <a:off x="468360" y="907920"/>
            <a:ext cx="765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10. Innate immunity signaling genes are listed with their mRNA levels in response to heat shock and MG132 treatment. Fold changes more than 2 are colored in red and less than -2 are colored in green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"/>
          <p:cNvGraphicFramePr/>
          <p:nvPr/>
        </p:nvGraphicFramePr>
        <p:xfrm>
          <a:off x="395280" y="399960"/>
          <a:ext cx="8353440" cy="6278760"/>
        </p:xfrm>
        <a:graphic>
          <a:graphicData uri="http://schemas.openxmlformats.org/drawingml/2006/table">
            <a:tbl>
              <a:tblPr/>
              <a:tblGrid>
                <a:gridCol w="2432160"/>
                <a:gridCol w="449280"/>
                <a:gridCol w="257040"/>
                <a:gridCol w="293760"/>
                <a:gridCol w="295200"/>
                <a:gridCol w="291960"/>
                <a:gridCol w="255600"/>
                <a:gridCol w="295560"/>
                <a:gridCol w="291960"/>
                <a:gridCol w="297000"/>
                <a:gridCol w="255600"/>
                <a:gridCol w="293400"/>
                <a:gridCol w="293760"/>
                <a:gridCol w="293760"/>
                <a:gridCol w="255600"/>
                <a:gridCol w="293760"/>
                <a:gridCol w="296640"/>
                <a:gridCol w="292320"/>
                <a:gridCol w="293760"/>
                <a:gridCol w="625320"/>
              </a:tblGrid>
              <a:tr h="244440"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Symb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H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H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RM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M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T/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ccession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(alpha and beta) recep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a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0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(alpha and beta)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a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0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activated gene 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2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activated gene 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2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activated gene 2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7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K08793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activated gene 2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2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5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7264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alpha responsive ge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rg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232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dependent positive acting transcription factor 3 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f3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6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8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dependent positive acting transcription factor 3 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f3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8.8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10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epsilo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t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7734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induced GTP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gt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12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10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5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873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inducible protein 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4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3065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inducible protein 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3065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recep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gr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1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g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3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gamma recep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ngr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3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ed transmembrane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68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ed transmembrane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6820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ed transmembrane protein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m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306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ed transmembrane protein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m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537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ed transmembrane protein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m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530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inducible GTPase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AI481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17.8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8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8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9440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91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2 binding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2b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9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9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178757.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84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9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84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8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7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7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6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84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2057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regulatory factor 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rf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5.5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9.6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85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stimulated exonuclease gene 20-lik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20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6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6531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 stimulated exonuclease gene 20-lik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20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9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6531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induced protein 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9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5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2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732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induced protein with tetratricopeptide repeats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2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6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08332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induced protein with tetratricopeptide repeats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5.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4.9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4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0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induced protein with tetratricopeptide repeats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it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1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.9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40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4.6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5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3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3.6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050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related developmental regulator 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frd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8000"/>
                          </a:solidFill>
                          <a:latin typeface="Arial Narrow"/>
                          <a:ea typeface="돋움"/>
                        </a:rPr>
                        <a:t>-2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1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9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590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nterferon-stimulated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Isg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6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2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20583.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172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rotein kinase, interferon inducible double stranded RNA dependent activato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rkr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4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3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187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804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rotein kinase, X-link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Prk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8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0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4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-1.5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ff0000"/>
                          </a:solidFill>
                          <a:latin typeface="Arial Narrow"/>
                          <a:ea typeface="돋움"/>
                        </a:rPr>
                        <a:t>2.1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7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2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5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1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Narrow"/>
                          <a:ea typeface="돋움"/>
                        </a:rPr>
                        <a:t>NM_01697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5" name="Text Box 869"/>
          <p:cNvSpPr/>
          <p:nvPr/>
        </p:nvSpPr>
        <p:spPr>
          <a:xfrm>
            <a:off x="103680" y="0"/>
            <a:ext cx="277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10b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02:05:28Z</dcterms:created>
  <dc:creator>김희정</dc:creator>
  <dc:description/>
  <dc:language>en-US</dc:language>
  <cp:lastModifiedBy>김희정</cp:lastModifiedBy>
  <dcterms:modified xsi:type="dcterms:W3CDTF">2011-06-14T03:18:04Z</dcterms:modified>
  <cp:revision>2</cp:revision>
  <dc:subject/>
  <dc:title>슬라이드 1</dc:title>
</cp:coreProperties>
</file>